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3362A62-1402-44A7-B947-C8D25B9E1B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2588676C-5031-4A0C-9E1C-CA107259D5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4B98AFA-AF2F-46F4-B416-8ACC05810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23E5298-C004-462F-90D6-FBB780ABD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F98C143-587B-4694-A122-99DC3D269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00584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FE92E97-8749-45A7-A348-697743C602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BD3D6375-D951-471E-B24F-EC89A03AB7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72C09469-2EBE-4C88-8B3D-5ECE3B681B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6A1B739-D897-44E6-9D02-D1E9D416BC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BFA3522-DE38-44E4-B546-258F3E9AE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61602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2EABAF55-E41F-4469-8091-0FDBE5C1E8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DC3C308B-2B0E-4C34-B82E-954CA47B02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D4381F3E-6859-4895-95B3-B1D4ABA09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85EF42D-3184-447E-9DAD-351206C5B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E2D9C972-E88C-4DBF-B070-44A5EEAE8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46744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D3F46FA-CC05-4CFE-9CC3-7298E2201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924C9655-2E74-47CB-A4F7-3626AAD3D5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201F4F0F-8CBF-4404-BA49-E8D626248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C9FA44F-40E9-436B-8C0F-EBE4640DB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FA09843-0C01-43C1-8738-CE1F4A6E3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27405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88E2BE6-6F0A-42B9-BF46-70DC3998D9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6D9DCCC3-BBCF-471F-96BD-0ED2BA3CDD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EF1E292-BF27-4017-9F6A-FC5B57832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27D48FE-A64D-49AC-BF38-70BF5A4C6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1DA82BE-F8CE-46EC-8F02-0EDF462E8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40495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51AD5F38-B0DB-4648-AA71-E5E8AB61BF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B714742D-FEA0-482E-AA8B-1ADFDB1A3B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1B8E805C-FA5C-4696-B1FD-8AB5B4C465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78E97EED-2858-4E40-A46A-C2A5AEDD6F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CBDF5848-9703-402F-95F6-AB37A6870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56DAC54A-8408-45AF-91B0-0BE9F9DAB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79147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8072F55-B257-44BE-B12E-6A54E843A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A757F33D-A019-45D9-8EA4-687E34DC6F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511DDACA-ECBF-4BEB-8A34-3872FBAF88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C56CB995-E75C-4213-B725-8EFEA1C810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7C74F9B8-D8DE-439D-8872-269C0B8A1F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8ADCF5A9-7194-40FF-818B-414B0BE47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E82A4969-5DA6-409B-8C04-D9D1DBEA2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3111010A-D850-413F-9E04-901A67D81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48674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7C404DA-17AE-4835-9980-B2A1C0DC7D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AEDB5CAA-A6AC-4210-AF24-8F195E126D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4C644CED-591A-45DE-B057-78E073A05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C96BDFAD-E7C1-448A-87FC-F67A04043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36319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7BB5C18C-28DD-4783-9BF8-47B24A217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3CBECF27-47DC-480E-8021-40AF2D98F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5218B4C6-0C28-4CBA-91A3-303338CD4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85939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36AE308-6C50-4161-AB14-6F9C7338A5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050FCC84-1648-44EE-9731-95C4FF7AD9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971A1D70-9F11-4568-BABF-73FDC853A3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4D0F858B-114C-494A-A3BE-89138A5A1B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068C65B2-B2AA-4AF6-A30B-A3415C671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8F232566-AFDD-4FE1-BC0E-247BFE4B2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82956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6F5A72C-2619-472D-822D-C1EA808446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131F289F-04B6-440F-AC08-227CDEFDF2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E7C1E284-429C-4BC7-9942-BF8C3D8769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9539374B-F51E-4A6D-ADC4-3E8BB98D2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4B3D8A71-C394-4D8C-A88B-F7620E838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DD4B91F1-C9C9-4DC0-8403-ED0CACB9B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79105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CC9F25CC-48DE-47B1-9C98-3698A508A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21CE9CD0-8FC9-4FF6-9303-0EFC142F50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873F6F44-F757-4812-B4B9-E464B322EF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11760-02F3-4423-9ED2-EC131906D4AF}" type="datetimeFigureOut">
              <a:rPr lang="zh-TW" altLang="en-US" smtClean="0"/>
              <a:t>2021/4/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B694681A-E1F9-4B09-8B33-19FE3998E9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8C11DD6C-984B-4354-9CD4-8ABA34778A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A9DE0-13E3-49CA-8458-2B8B157485C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33502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550088E7-F4A3-455B-BCEB-3FBE808DD9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4141511"/>
              </p:ext>
            </p:extLst>
          </p:nvPr>
        </p:nvGraphicFramePr>
        <p:xfrm>
          <a:off x="833641" y="931958"/>
          <a:ext cx="10387732" cy="39319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58596">
                  <a:extLst>
                    <a:ext uri="{9D8B030D-6E8A-4147-A177-3AD203B41FA5}">
                      <a16:colId xmlns:a16="http://schemas.microsoft.com/office/drawing/2014/main" val="493805829"/>
                    </a:ext>
                  </a:extLst>
                </a:gridCol>
                <a:gridCol w="945466">
                  <a:extLst>
                    <a:ext uri="{9D8B030D-6E8A-4147-A177-3AD203B41FA5}">
                      <a16:colId xmlns:a16="http://schemas.microsoft.com/office/drawing/2014/main" val="3118663803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614390674"/>
                    </a:ext>
                  </a:extLst>
                </a:gridCol>
                <a:gridCol w="1171363">
                  <a:extLst>
                    <a:ext uri="{9D8B030D-6E8A-4147-A177-3AD203B41FA5}">
                      <a16:colId xmlns:a16="http://schemas.microsoft.com/office/drawing/2014/main" val="2171934898"/>
                    </a:ext>
                  </a:extLst>
                </a:gridCol>
                <a:gridCol w="1040907">
                  <a:extLst>
                    <a:ext uri="{9D8B030D-6E8A-4147-A177-3AD203B41FA5}">
                      <a16:colId xmlns:a16="http://schemas.microsoft.com/office/drawing/2014/main" val="3329290461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581685478"/>
                    </a:ext>
                  </a:extLst>
                </a:gridCol>
                <a:gridCol w="813455">
                  <a:extLst>
                    <a:ext uri="{9D8B030D-6E8A-4147-A177-3AD203B41FA5}">
                      <a16:colId xmlns:a16="http://schemas.microsoft.com/office/drawing/2014/main" val="4080782623"/>
                    </a:ext>
                  </a:extLst>
                </a:gridCol>
                <a:gridCol w="813455">
                  <a:extLst>
                    <a:ext uri="{9D8B030D-6E8A-4147-A177-3AD203B41FA5}">
                      <a16:colId xmlns:a16="http://schemas.microsoft.com/office/drawing/2014/main" val="3513052215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1197495652"/>
                    </a:ext>
                  </a:extLst>
                </a:gridCol>
                <a:gridCol w="798671">
                  <a:extLst>
                    <a:ext uri="{9D8B030D-6E8A-4147-A177-3AD203B41FA5}">
                      <a16:colId xmlns:a16="http://schemas.microsoft.com/office/drawing/2014/main" val="3531469542"/>
                    </a:ext>
                  </a:extLst>
                </a:gridCol>
                <a:gridCol w="798671">
                  <a:extLst>
                    <a:ext uri="{9D8B030D-6E8A-4147-A177-3AD203B41FA5}">
                      <a16:colId xmlns:a16="http://schemas.microsoft.com/office/drawing/2014/main" val="2188875022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545151859"/>
                    </a:ext>
                  </a:extLst>
                </a:gridCol>
                <a:gridCol w="1257014">
                  <a:extLst>
                    <a:ext uri="{9D8B030D-6E8A-4147-A177-3AD203B41FA5}">
                      <a16:colId xmlns:a16="http://schemas.microsoft.com/office/drawing/2014/main" val="3533224252"/>
                    </a:ext>
                  </a:extLst>
                </a:gridCol>
                <a:gridCol w="1257014">
                  <a:extLst>
                    <a:ext uri="{9D8B030D-6E8A-4147-A177-3AD203B41FA5}">
                      <a16:colId xmlns:a16="http://schemas.microsoft.com/office/drawing/2014/main" val="3473794420"/>
                    </a:ext>
                  </a:extLst>
                </a:gridCol>
              </a:tblGrid>
              <a:tr h="371655"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grade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No.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1/2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p19q codeletion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TW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T promoter mutation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TW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MT promoter methylation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TW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3375304"/>
                  </a:ext>
                </a:extLst>
              </a:tr>
              <a:tr h="262532">
                <a:tc vMerge="1">
                  <a:txBody>
                    <a:bodyPr/>
                    <a:lstStyle/>
                    <a:p>
                      <a:endParaRPr lang="zh-TW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sue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sue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sue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sue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1189650"/>
                  </a:ext>
                </a:extLst>
              </a:tr>
              <a:tr h="26253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919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1:R132H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p19q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28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2713463"/>
                  </a:ext>
                </a:extLst>
              </a:tr>
              <a:tr h="26253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933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新細明體" panose="02020500000000000000" pitchFamily="18" charset="-12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73029491"/>
                  </a:ext>
                </a:extLst>
              </a:tr>
              <a:tr h="26253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937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1:R132H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p19q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28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76349436"/>
                  </a:ext>
                </a:extLst>
              </a:tr>
              <a:tr h="26253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946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2:R140Q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28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34124083"/>
                  </a:ext>
                </a:extLst>
              </a:tr>
              <a:tr h="37165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928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1:R132H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2:R140Q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p19q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28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55735171"/>
                  </a:ext>
                </a:extLst>
              </a:tr>
              <a:tr h="26253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950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1:R132H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p19q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28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43302461"/>
                  </a:ext>
                </a:extLst>
              </a:tr>
              <a:tr h="26253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952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1:R132H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78098397"/>
                  </a:ext>
                </a:extLst>
              </a:tr>
              <a:tr h="26253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802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28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28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0386128"/>
                  </a:ext>
                </a:extLst>
              </a:tr>
              <a:tr h="26253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909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q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1520193"/>
                  </a:ext>
                </a:extLst>
              </a:tr>
              <a:tr h="26253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935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q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28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28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98937905"/>
                  </a:ext>
                </a:extLst>
              </a:tr>
              <a:tr h="262532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958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en-US" altLang="zh-TW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T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ac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228T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lang="zh-TW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54813016"/>
                  </a:ext>
                </a:extLst>
              </a:tr>
            </a:tbl>
          </a:graphicData>
        </a:graphic>
      </p:graphicFrame>
      <p:sp>
        <p:nvSpPr>
          <p:cNvPr id="7" name="文字方塊 6">
            <a:extLst>
              <a:ext uri="{FF2B5EF4-FFF2-40B4-BE49-F238E27FC236}">
                <a16:creationId xmlns:a16="http://schemas.microsoft.com/office/drawing/2014/main" id="{0074DEC2-5EC9-496E-B84F-2701C5B4EFC1}"/>
              </a:ext>
            </a:extLst>
          </p:cNvPr>
          <p:cNvSpPr txBox="1"/>
          <p:nvPr/>
        </p:nvSpPr>
        <p:spPr>
          <a:xfrm>
            <a:off x="833641" y="470293"/>
            <a:ext cx="107961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TW" sz="1200">
                <a:latin typeface="Arial" panose="020B0604020202020204" pitchFamily="34" charset="0"/>
                <a:cs typeface="Arial" panose="020B0604020202020204" pitchFamily="34" charset="0"/>
              </a:rPr>
              <a:t>Table 6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TW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The status of </a:t>
            </a:r>
            <a:r>
              <a:rPr lang="en-US" altLang="zh-TW" sz="1200" i="1" dirty="0">
                <a:latin typeface="Arial" panose="020B0604020202020204" pitchFamily="34" charset="0"/>
                <a:cs typeface="Arial" panose="020B0604020202020204" pitchFamily="34" charset="0"/>
              </a:rPr>
              <a:t>IDH 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mutation, 1p/19q codeletion, </a:t>
            </a:r>
            <a:r>
              <a:rPr lang="en-US" altLang="zh-TW" sz="1200" i="1" dirty="0">
                <a:latin typeface="Arial" panose="020B0604020202020204" pitchFamily="34" charset="0"/>
                <a:cs typeface="Arial" panose="020B0604020202020204" pitchFamily="34" charset="0"/>
              </a:rPr>
              <a:t>TERT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 promoter mutation, and </a:t>
            </a:r>
            <a:r>
              <a:rPr lang="en-US" altLang="zh-TW" sz="1200" i="1" dirty="0">
                <a:latin typeface="Arial" panose="020B0604020202020204" pitchFamily="34" charset="0"/>
                <a:cs typeface="Arial" panose="020B0604020202020204" pitchFamily="34" charset="0"/>
              </a:rPr>
              <a:t>MGMT 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promoter methylation in paired tumors and primary cells 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4515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76</Words>
  <Application>Microsoft Office PowerPoint</Application>
  <PresentationFormat>寬螢幕</PresentationFormat>
  <Paragraphs>126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家嬅 陳</dc:creator>
  <cp:lastModifiedBy>家嬅 陳</cp:lastModifiedBy>
  <cp:revision>2</cp:revision>
  <dcterms:created xsi:type="dcterms:W3CDTF">2020-10-07T04:14:12Z</dcterms:created>
  <dcterms:modified xsi:type="dcterms:W3CDTF">2021-04-02T13:03:00Z</dcterms:modified>
</cp:coreProperties>
</file>